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</p:sldIdLst>
  <p:sldSz cx="12192000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3"/>
    <p:restoredTop sz="94660"/>
  </p:normalViewPr>
  <p:slideViewPr>
    <p:cSldViewPr snapToGrid="0" snapToObjects="1">
      <p:cViewPr varScale="1">
        <p:scale>
          <a:sx n="84" d="100"/>
          <a:sy n="84" d="100"/>
        </p:scale>
        <p:origin x="156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72842"/>
            <a:ext cx="10363200" cy="3133172"/>
          </a:xfrm>
        </p:spPr>
        <p:txBody>
          <a:bodyPr anchor="b"/>
          <a:lstStyle>
            <a:lvl1pPr algn="ctr">
              <a:defRPr sz="7874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726842"/>
            <a:ext cx="9144000" cy="2172804"/>
          </a:xfrm>
        </p:spPr>
        <p:txBody>
          <a:bodyPr/>
          <a:lstStyle>
            <a:lvl1pPr marL="0" indent="0" algn="ctr">
              <a:buNone/>
              <a:defRPr sz="3150"/>
            </a:lvl1pPr>
            <a:lvl2pPr marL="599984" indent="0" algn="ctr">
              <a:buNone/>
              <a:defRPr sz="2625"/>
            </a:lvl2pPr>
            <a:lvl3pPr marL="1199967" indent="0" algn="ctr">
              <a:buNone/>
              <a:defRPr sz="2362"/>
            </a:lvl3pPr>
            <a:lvl4pPr marL="1799951" indent="0" algn="ctr">
              <a:buNone/>
              <a:defRPr sz="2100"/>
            </a:lvl4pPr>
            <a:lvl5pPr marL="2399934" indent="0" algn="ctr">
              <a:buNone/>
              <a:defRPr sz="2100"/>
            </a:lvl5pPr>
            <a:lvl6pPr marL="2999918" indent="0" algn="ctr">
              <a:buNone/>
              <a:defRPr sz="2100"/>
            </a:lvl6pPr>
            <a:lvl7pPr marL="3599901" indent="0" algn="ctr">
              <a:buNone/>
              <a:defRPr sz="2100"/>
            </a:lvl7pPr>
            <a:lvl8pPr marL="4199885" indent="0" algn="ctr">
              <a:buNone/>
              <a:defRPr sz="2100"/>
            </a:lvl8pPr>
            <a:lvl9pPr marL="4799868" indent="0" algn="ctr">
              <a:buNone/>
              <a:defRPr sz="21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E419A-8391-BF4A-9A7D-56CDE89DAB5C}" type="datetimeFigureOut">
              <a:rPr lang="en-US" smtClean="0"/>
              <a:t>7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1EEF6-7EE8-2148-BF8C-FA7ED6728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9924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E419A-8391-BF4A-9A7D-56CDE89DAB5C}" type="datetimeFigureOut">
              <a:rPr lang="en-US" smtClean="0"/>
              <a:t>7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1EEF6-7EE8-2148-BF8C-FA7ED6728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480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79142"/>
            <a:ext cx="2628900" cy="7626692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79142"/>
            <a:ext cx="7734300" cy="7626692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E419A-8391-BF4A-9A7D-56CDE89DAB5C}" type="datetimeFigureOut">
              <a:rPr lang="en-US" smtClean="0"/>
              <a:t>7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1EEF6-7EE8-2148-BF8C-FA7ED6728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6913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E419A-8391-BF4A-9A7D-56CDE89DAB5C}" type="datetimeFigureOut">
              <a:rPr lang="en-US" smtClean="0"/>
              <a:t>7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1EEF6-7EE8-2148-BF8C-FA7ED6728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81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43638"/>
            <a:ext cx="10515600" cy="3743557"/>
          </a:xfrm>
        </p:spPr>
        <p:txBody>
          <a:bodyPr anchor="b"/>
          <a:lstStyle>
            <a:lvl1pPr>
              <a:defRPr sz="7874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022610"/>
            <a:ext cx="10515600" cy="1968648"/>
          </a:xfrm>
        </p:spPr>
        <p:txBody>
          <a:bodyPr/>
          <a:lstStyle>
            <a:lvl1pPr marL="0" indent="0">
              <a:buNone/>
              <a:defRPr sz="3150">
                <a:solidFill>
                  <a:schemeClr val="tx1"/>
                </a:solidFill>
              </a:defRPr>
            </a:lvl1pPr>
            <a:lvl2pPr marL="599984" indent="0">
              <a:buNone/>
              <a:defRPr sz="2625">
                <a:solidFill>
                  <a:schemeClr val="tx1">
                    <a:tint val="75000"/>
                  </a:schemeClr>
                </a:solidFill>
              </a:defRPr>
            </a:lvl2pPr>
            <a:lvl3pPr marL="1199967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179995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39993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299991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359990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19988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479986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E419A-8391-BF4A-9A7D-56CDE89DAB5C}" type="datetimeFigureOut">
              <a:rPr lang="en-US" smtClean="0"/>
              <a:t>7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1EEF6-7EE8-2148-BF8C-FA7ED6728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37777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395710"/>
            <a:ext cx="5181600" cy="571012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395710"/>
            <a:ext cx="5181600" cy="571012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E419A-8391-BF4A-9A7D-56CDE89DAB5C}" type="datetimeFigureOut">
              <a:rPr lang="en-US" smtClean="0"/>
              <a:t>7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1EEF6-7EE8-2148-BF8C-FA7ED6728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0766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79144"/>
            <a:ext cx="10515600" cy="1739495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06137"/>
            <a:ext cx="5157787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287331"/>
            <a:ext cx="5157787" cy="483516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06137"/>
            <a:ext cx="5183188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287331"/>
            <a:ext cx="5183188" cy="483516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E419A-8391-BF4A-9A7D-56CDE89DAB5C}" type="datetimeFigureOut">
              <a:rPr lang="en-US" smtClean="0"/>
              <a:t>7/1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1EEF6-7EE8-2148-BF8C-FA7ED6728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883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E419A-8391-BF4A-9A7D-56CDE89DAB5C}" type="datetimeFigureOut">
              <a:rPr lang="en-US" smtClean="0"/>
              <a:t>7/1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1EEF6-7EE8-2148-BF8C-FA7ED6728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182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E419A-8391-BF4A-9A7D-56CDE89DAB5C}" type="datetimeFigureOut">
              <a:rPr lang="en-US" smtClean="0"/>
              <a:t>7/1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1EEF6-7EE8-2148-BF8C-FA7ED6728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5290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99969"/>
            <a:ext cx="3932237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295769"/>
            <a:ext cx="6172200" cy="6395505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99862"/>
            <a:ext cx="3932237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E419A-8391-BF4A-9A7D-56CDE89DAB5C}" type="datetimeFigureOut">
              <a:rPr lang="en-US" smtClean="0"/>
              <a:t>7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1EEF6-7EE8-2148-BF8C-FA7ED6728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0142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99969"/>
            <a:ext cx="3932237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295769"/>
            <a:ext cx="6172200" cy="6395505"/>
          </a:xfrm>
        </p:spPr>
        <p:txBody>
          <a:bodyPr anchor="t"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99862"/>
            <a:ext cx="3932237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0E419A-8391-BF4A-9A7D-56CDE89DAB5C}" type="datetimeFigureOut">
              <a:rPr lang="en-US" smtClean="0"/>
              <a:t>7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1EEF6-7EE8-2148-BF8C-FA7ED6728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3710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79144"/>
            <a:ext cx="10515600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395710"/>
            <a:ext cx="10515600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341240"/>
            <a:ext cx="27432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0E419A-8391-BF4A-9A7D-56CDE89DAB5C}" type="datetimeFigureOut">
              <a:rPr lang="en-US" smtClean="0"/>
              <a:t>7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341240"/>
            <a:ext cx="41148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341240"/>
            <a:ext cx="27432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E1EEF6-7EE8-2148-BF8C-FA7ED6728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98142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199967" rtl="0" eaLnBrk="1" latinLnBrk="0" hangingPunct="1">
        <a:lnSpc>
          <a:spcPct val="90000"/>
        </a:lnSpc>
        <a:spcBef>
          <a:spcPct val="0"/>
        </a:spcBef>
        <a:buNone/>
        <a:defRPr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992" indent="-299992" algn="l" defTabSz="119996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3674" kern="1200">
          <a:solidFill>
            <a:schemeClr val="tx1"/>
          </a:solidFill>
          <a:latin typeface="+mn-lt"/>
          <a:ea typeface="+mn-ea"/>
          <a:cs typeface="+mn-cs"/>
        </a:defRPr>
      </a:lvl1pPr>
      <a:lvl2pPr marL="899975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625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png"/><Relationship Id="rId7" Type="http://schemas.openxmlformats.org/officeDocument/2006/relationships/image" Target="../media/image6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png"/><Relationship Id="rId10" Type="http://schemas.openxmlformats.org/officeDocument/2006/relationships/image" Target="../media/image9.tiff"/><Relationship Id="rId4" Type="http://schemas.openxmlformats.org/officeDocument/2006/relationships/image" Target="../media/image3.png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BA40D14-1C1A-3E41-82EC-AB240AD7287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60000"/>
                    </a14:imgEffect>
                  </a14:imgLayer>
                </a14:imgProps>
              </a:ext>
            </a:extLst>
          </a:blip>
          <a:srcRect l="20139"/>
          <a:stretch/>
        </p:blipFill>
        <p:spPr>
          <a:xfrm>
            <a:off x="120572" y="981196"/>
            <a:ext cx="2282400" cy="228079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CFA435D-445E-F54F-AE3C-A9725C11B8B3}"/>
              </a:ext>
            </a:extLst>
          </p:cNvPr>
          <p:cNvSpPr txBox="1"/>
          <p:nvPr/>
        </p:nvSpPr>
        <p:spPr>
          <a:xfrm>
            <a:off x="120571" y="618336"/>
            <a:ext cx="707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ay 7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FC1BE78-8C10-884F-8CBE-C9E7444761B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colorTemperature colorTemp="2500"/>
                    </a14:imgEffect>
                  </a14:imgLayer>
                </a14:imgProps>
              </a:ext>
            </a:extLst>
          </a:blip>
          <a:srcRect l="29166" b="5337"/>
          <a:stretch/>
        </p:blipFill>
        <p:spPr>
          <a:xfrm>
            <a:off x="7317825" y="964374"/>
            <a:ext cx="2278695" cy="22824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F71D8E6-EB6E-D143-A484-E0EE7988D9D0}"/>
              </a:ext>
            </a:extLst>
          </p:cNvPr>
          <p:cNvSpPr txBox="1"/>
          <p:nvPr/>
        </p:nvSpPr>
        <p:spPr>
          <a:xfrm>
            <a:off x="7317823" y="618336"/>
            <a:ext cx="8247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ay 11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0E940B0-76FA-4D4D-963C-A4A64BD3438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colorTemperature colorTemp="3000"/>
                    </a14:imgEffect>
                    <a14:imgEffect>
                      <a14:brightnessContrast bright="15000"/>
                    </a14:imgEffect>
                  </a14:imgLayer>
                </a14:imgProps>
              </a:ext>
            </a:extLst>
          </a:blip>
          <a:srcRect l="31603" t="45700" r="25267" b="1"/>
          <a:stretch/>
        </p:blipFill>
        <p:spPr>
          <a:xfrm>
            <a:off x="9657757" y="964374"/>
            <a:ext cx="2271751" cy="22824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671066DB-D58D-6D43-A39A-E9DC9FB6BFB2}"/>
              </a:ext>
            </a:extLst>
          </p:cNvPr>
          <p:cNvSpPr txBox="1"/>
          <p:nvPr/>
        </p:nvSpPr>
        <p:spPr>
          <a:xfrm>
            <a:off x="9657755" y="618336"/>
            <a:ext cx="8247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ay 1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46C7EAC-738D-4444-8FEE-3B2C5E3646E2}"/>
              </a:ext>
            </a:extLst>
          </p:cNvPr>
          <p:cNvSpPr txBox="1"/>
          <p:nvPr/>
        </p:nvSpPr>
        <p:spPr>
          <a:xfrm>
            <a:off x="125180" y="4049005"/>
            <a:ext cx="8247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ay 1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AF51F73-6CD5-0C4C-BE35-25EA7D1457A3}"/>
              </a:ext>
            </a:extLst>
          </p:cNvPr>
          <p:cNvSpPr txBox="1"/>
          <p:nvPr/>
        </p:nvSpPr>
        <p:spPr>
          <a:xfrm>
            <a:off x="2447663" y="4049005"/>
            <a:ext cx="8247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ay 16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CD1D498-3C2E-8D4A-A5B4-FB7DBA78F7E2}"/>
              </a:ext>
            </a:extLst>
          </p:cNvPr>
          <p:cNvSpPr txBox="1"/>
          <p:nvPr/>
        </p:nvSpPr>
        <p:spPr>
          <a:xfrm>
            <a:off x="7594951" y="4049005"/>
            <a:ext cx="8247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ay 18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08AF7FE9-C1BC-D44B-ACDA-518FB510506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9557" t="12543" r="23728" b="4111"/>
          <a:stretch/>
        </p:blipFill>
        <p:spPr>
          <a:xfrm>
            <a:off x="103486" y="4436242"/>
            <a:ext cx="2272183" cy="2265307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5145DF54-3933-D347-8025-27E14C70EF6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37429" t="11993" r="15361" b="28850"/>
          <a:stretch/>
        </p:blipFill>
        <p:spPr>
          <a:xfrm>
            <a:off x="2425968" y="4436242"/>
            <a:ext cx="2265306" cy="2265307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0A2E0E08-D5D0-374D-8301-4CB9720F8C9B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8602" t="3871" r="23381" b="23382"/>
          <a:stretch/>
        </p:blipFill>
        <p:spPr>
          <a:xfrm>
            <a:off x="7594952" y="4418338"/>
            <a:ext cx="2263781" cy="2265307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972D8AA8-D0D2-1642-ACA4-83B6CE59BECC}"/>
              </a:ext>
            </a:extLst>
          </p:cNvPr>
          <p:cNvSpPr txBox="1"/>
          <p:nvPr/>
        </p:nvSpPr>
        <p:spPr>
          <a:xfrm>
            <a:off x="103485" y="278672"/>
            <a:ext cx="148630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Sarisha-14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F0267FF-9B4E-E143-8AEF-A20131F15826}"/>
              </a:ext>
            </a:extLst>
          </p:cNvPr>
          <p:cNvSpPr txBox="1"/>
          <p:nvPr/>
        </p:nvSpPr>
        <p:spPr>
          <a:xfrm>
            <a:off x="209040" y="3587341"/>
            <a:ext cx="12298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R-o-18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61BEF892-5E47-3D46-830A-DBB5ED6BDCF2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4820" t="13891" r="16328" b="16839"/>
          <a:stretch/>
        </p:blipFill>
        <p:spPr>
          <a:xfrm>
            <a:off x="4735822" y="4436242"/>
            <a:ext cx="2814583" cy="2265307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833777C4-4A82-6A4A-A547-CCB34CD39391}"/>
              </a:ext>
            </a:extLst>
          </p:cNvPr>
          <p:cNvSpPr txBox="1"/>
          <p:nvPr/>
        </p:nvSpPr>
        <p:spPr>
          <a:xfrm>
            <a:off x="4723132" y="4049005"/>
            <a:ext cx="8247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ay 17</a:t>
            </a:r>
          </a:p>
        </p:txBody>
      </p:sp>
      <p:sp>
        <p:nvSpPr>
          <p:cNvPr id="19" name="Triangle 18">
            <a:extLst>
              <a:ext uri="{FF2B5EF4-FFF2-40B4-BE49-F238E27FC236}">
                <a16:creationId xmlns:a16="http://schemas.microsoft.com/office/drawing/2014/main" id="{844E7054-7085-7042-B6A2-4766FA81D91B}"/>
              </a:ext>
            </a:extLst>
          </p:cNvPr>
          <p:cNvSpPr/>
          <p:nvPr/>
        </p:nvSpPr>
        <p:spPr>
          <a:xfrm rot="2642169">
            <a:off x="7759241" y="2244908"/>
            <a:ext cx="110303" cy="312367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riangle 19">
            <a:extLst>
              <a:ext uri="{FF2B5EF4-FFF2-40B4-BE49-F238E27FC236}">
                <a16:creationId xmlns:a16="http://schemas.microsoft.com/office/drawing/2014/main" id="{899A7648-D8A1-C743-93C2-0124DC95C38B}"/>
              </a:ext>
            </a:extLst>
          </p:cNvPr>
          <p:cNvSpPr/>
          <p:nvPr/>
        </p:nvSpPr>
        <p:spPr>
          <a:xfrm rot="2642169">
            <a:off x="7795528" y="1787708"/>
            <a:ext cx="110303" cy="312367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riangle 21">
            <a:extLst>
              <a:ext uri="{FF2B5EF4-FFF2-40B4-BE49-F238E27FC236}">
                <a16:creationId xmlns:a16="http://schemas.microsoft.com/office/drawing/2014/main" id="{B6623151-9688-9B49-A44C-B705A1DEB0F4}"/>
              </a:ext>
            </a:extLst>
          </p:cNvPr>
          <p:cNvSpPr/>
          <p:nvPr/>
        </p:nvSpPr>
        <p:spPr>
          <a:xfrm rot="5400000">
            <a:off x="5739521" y="5316740"/>
            <a:ext cx="110303" cy="312367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riangle 22">
            <a:extLst>
              <a:ext uri="{FF2B5EF4-FFF2-40B4-BE49-F238E27FC236}">
                <a16:creationId xmlns:a16="http://schemas.microsoft.com/office/drawing/2014/main" id="{0A766DEC-A824-934A-B0A8-A620FD7BFB26}"/>
              </a:ext>
            </a:extLst>
          </p:cNvPr>
          <p:cNvSpPr/>
          <p:nvPr/>
        </p:nvSpPr>
        <p:spPr>
          <a:xfrm rot="19137103">
            <a:off x="6457980" y="5527199"/>
            <a:ext cx="110303" cy="312367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5F97C53-43EC-1E48-9E9C-5D06815471F1}"/>
              </a:ext>
            </a:extLst>
          </p:cNvPr>
          <p:cNvSpPr txBox="1"/>
          <p:nvPr/>
        </p:nvSpPr>
        <p:spPr>
          <a:xfrm>
            <a:off x="2459652" y="618336"/>
            <a:ext cx="707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ay 9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5FE8C28-F780-EA44-9F0F-9BD9B2615C31}"/>
              </a:ext>
            </a:extLst>
          </p:cNvPr>
          <p:cNvSpPr txBox="1"/>
          <p:nvPr/>
        </p:nvSpPr>
        <p:spPr>
          <a:xfrm>
            <a:off x="4902780" y="618336"/>
            <a:ext cx="8247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ay 10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49093236-586F-6948-ADBC-5CD3E1173A6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879873" y="970128"/>
            <a:ext cx="2376714" cy="2282400"/>
          </a:xfrm>
          <a:prstGeom prst="rect">
            <a:avLst/>
          </a:prstGeom>
        </p:spPr>
      </p:pic>
      <p:sp>
        <p:nvSpPr>
          <p:cNvPr id="21" name="Triangle 20">
            <a:extLst>
              <a:ext uri="{FF2B5EF4-FFF2-40B4-BE49-F238E27FC236}">
                <a16:creationId xmlns:a16="http://schemas.microsoft.com/office/drawing/2014/main" id="{C16BE373-4550-4C4B-AA27-BC08C68CADEE}"/>
              </a:ext>
            </a:extLst>
          </p:cNvPr>
          <p:cNvSpPr/>
          <p:nvPr/>
        </p:nvSpPr>
        <p:spPr>
          <a:xfrm rot="9761541">
            <a:off x="5984913" y="1481303"/>
            <a:ext cx="110303" cy="312367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9AC4EAFE-C028-A847-909B-B6B03D37DCF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456986" y="982991"/>
            <a:ext cx="2361650" cy="2282400"/>
          </a:xfrm>
          <a:prstGeom prst="rect">
            <a:avLst/>
          </a:prstGeom>
        </p:spPr>
      </p:pic>
      <p:sp>
        <p:nvSpPr>
          <p:cNvPr id="18" name="Rectangle 17">
            <a:extLst>
              <a:ext uri="{FF2B5EF4-FFF2-40B4-BE49-F238E27FC236}">
                <a16:creationId xmlns:a16="http://schemas.microsoft.com/office/drawing/2014/main" id="{6FD7CF92-F7D8-6A4F-930F-3DB169B9E55F}"/>
              </a:ext>
            </a:extLst>
          </p:cNvPr>
          <p:cNvSpPr/>
          <p:nvPr/>
        </p:nvSpPr>
        <p:spPr>
          <a:xfrm>
            <a:off x="241146" y="6827396"/>
            <a:ext cx="11688362" cy="129586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</a:t>
            </a:r>
            <a:r>
              <a:rPr lang="en-GB" b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7:</a:t>
            </a:r>
            <a:endParaRPr lang="en-GB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GB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pices of Sarisha-14 have floral morphology by day 10, R-o-18 has floral morphology by day 17. </a:t>
            </a:r>
            <a:r>
              <a:rPr lang="en-GB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loral meristems are highlighted with white arrows.</a:t>
            </a:r>
          </a:p>
        </p:txBody>
      </p:sp>
    </p:spTree>
    <p:extLst>
      <p:ext uri="{BB962C8B-B14F-4D97-AF65-F5344CB8AC3E}">
        <p14:creationId xmlns:p14="http://schemas.microsoft.com/office/powerpoint/2010/main" val="32771563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50</Words>
  <Application>Microsoft Macintosh PowerPoint</Application>
  <PresentationFormat>Custom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ander Calderwood (JIC)</dc:creator>
  <cp:lastModifiedBy>Alexander Calderwood (JIC)</cp:lastModifiedBy>
  <cp:revision>4</cp:revision>
  <dcterms:created xsi:type="dcterms:W3CDTF">2019-11-17T15:20:53Z</dcterms:created>
  <dcterms:modified xsi:type="dcterms:W3CDTF">2020-07-10T11:16:07Z</dcterms:modified>
</cp:coreProperties>
</file>